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6" r:id="rId3"/>
    <p:sldId id="257" r:id="rId4"/>
    <p:sldId id="261" r:id="rId5"/>
    <p:sldId id="258" r:id="rId6"/>
    <p:sldId id="259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65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3012" y="36"/>
      </p:cViewPr>
      <p:guideLst>
        <p:guide orient="horz" pos="309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511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326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63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221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630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456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170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35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034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34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519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A23133-23A4-4531-BCA9-C1748ED240B9}" type="datetimeFigureOut">
              <a:rPr lang="en-US" smtClean="0"/>
              <a:t>11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E8B4D8-6882-47EC-88F0-CDC2F03130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836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/>
          <a:srcRect t="-5732" r="-1344" b="-25371"/>
          <a:stretch/>
        </p:blipFill>
        <p:spPr>
          <a:xfrm>
            <a:off x="604835" y="1965036"/>
            <a:ext cx="5547195" cy="2143040"/>
          </a:xfrm>
          <a:prstGeom prst="rect">
            <a:avLst/>
          </a:prstGeom>
          <a:ln>
            <a:noFill/>
          </a:ln>
        </p:spPr>
      </p:pic>
      <p:sp>
        <p:nvSpPr>
          <p:cNvPr id="5" name="Rectangle 4"/>
          <p:cNvSpPr/>
          <p:nvPr/>
        </p:nvSpPr>
        <p:spPr>
          <a:xfrm>
            <a:off x="604835" y="2810435"/>
            <a:ext cx="827277" cy="27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3547499" y="2901556"/>
            <a:ext cx="827277" cy="27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764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7373" y="198367"/>
            <a:ext cx="4902200" cy="36830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2569" y="4025900"/>
            <a:ext cx="4902200" cy="36830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707419" y="396510"/>
            <a:ext cx="1181438" cy="8577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072950" y="396510"/>
            <a:ext cx="1181438" cy="8577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3429000" y="5509328"/>
            <a:ext cx="1181438" cy="8577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ZoneTexte 8"/>
          <p:cNvSpPr txBox="1"/>
          <p:nvPr/>
        </p:nvSpPr>
        <p:spPr>
          <a:xfrm>
            <a:off x="1107373" y="8294336"/>
            <a:ext cx="813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A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3833610" y="5509328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P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2052013" y="396510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bEF1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3410096" y="396510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19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19422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1552435" y="4539632"/>
            <a:ext cx="813043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B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67" r="14113" b="19918"/>
          <a:stretch/>
        </p:blipFill>
        <p:spPr>
          <a:xfrm rot="5400000" flipH="1">
            <a:off x="1516005" y="1681758"/>
            <a:ext cx="2518263" cy="2882938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958956" y="2467713"/>
            <a:ext cx="1281785" cy="9872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3471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21" t="-6063" r="-1783" b="-3219"/>
          <a:stretch/>
        </p:blipFill>
        <p:spPr>
          <a:xfrm>
            <a:off x="-171451" y="4348905"/>
            <a:ext cx="7029451" cy="2085863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955" r="-602" b="5526"/>
          <a:stretch/>
        </p:blipFill>
        <p:spPr>
          <a:xfrm>
            <a:off x="111211" y="647701"/>
            <a:ext cx="6655689" cy="3271222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709594" y="1087395"/>
            <a:ext cx="1522969" cy="7414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4303131" y="1122288"/>
            <a:ext cx="1497594" cy="7414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1583465" y="4830205"/>
            <a:ext cx="1502635" cy="9705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123304" y="4830205"/>
            <a:ext cx="1637270" cy="9705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ZoneTexte 11"/>
          <p:cNvSpPr txBox="1"/>
          <p:nvPr/>
        </p:nvSpPr>
        <p:spPr>
          <a:xfrm>
            <a:off x="2095015" y="1088765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A / PSA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4345645" y="1088765"/>
            <a:ext cx="1412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YMV amplicon / PSA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1903684" y="4830205"/>
            <a:ext cx="9989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A / NbEF1-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4180454" y="4862582"/>
            <a:ext cx="1659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YMV amplicon / NbEF1-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1616989" y="6900082"/>
            <a:ext cx="813043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A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6122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6319" y="238827"/>
            <a:ext cx="4902200" cy="36830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164" y="4205048"/>
            <a:ext cx="4902200" cy="36830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998733" y="4717657"/>
            <a:ext cx="1675051" cy="7282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982549" y="6569385"/>
            <a:ext cx="1675051" cy="7282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1998733" y="2353320"/>
            <a:ext cx="1675051" cy="7282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ZoneTexte 8"/>
          <p:cNvSpPr txBox="1"/>
          <p:nvPr/>
        </p:nvSpPr>
        <p:spPr>
          <a:xfrm>
            <a:off x="2273862" y="2500439"/>
            <a:ext cx="11689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bEF1-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Afor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2126182" y="4717657"/>
            <a:ext cx="12186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bEF1-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igodT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2273862" y="6569385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A (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Afor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592211" y="8262157"/>
            <a:ext cx="702436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91835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space réservé du contenu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8636" y="2785800"/>
            <a:ext cx="3045600" cy="2167200"/>
          </a:xfrm>
        </p:spPr>
      </p:pic>
      <p:sp>
        <p:nvSpPr>
          <p:cNvPr id="5" name="ZoneTexte 4"/>
          <p:cNvSpPr txBox="1"/>
          <p:nvPr/>
        </p:nvSpPr>
        <p:spPr>
          <a:xfrm>
            <a:off x="1617171" y="6489812"/>
            <a:ext cx="702436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8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395242" y="3018329"/>
            <a:ext cx="1456567" cy="10600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0351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4</TotalTime>
  <Words>44</Words>
  <Application>Microsoft Office PowerPoint</Application>
  <PresentationFormat>Format A4 (210 x 297 mm)</PresentationFormat>
  <Paragraphs>15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I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RD</dc:creator>
  <cp:lastModifiedBy>IRD</cp:lastModifiedBy>
  <cp:revision>12</cp:revision>
  <dcterms:created xsi:type="dcterms:W3CDTF">2023-11-06T14:38:07Z</dcterms:created>
  <dcterms:modified xsi:type="dcterms:W3CDTF">2023-11-09T10:59:09Z</dcterms:modified>
</cp:coreProperties>
</file>